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notesMasterIdLst>
    <p:notesMasterId r:id="rId3"/>
  </p:notesMasterIdLst>
  <p:sldIdLst>
    <p:sldId id="453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57">
          <p15:clr>
            <a:srgbClr val="A4A3A4"/>
          </p15:clr>
        </p15:guide>
        <p15:guide id="2" pos="2082">
          <p15:clr>
            <a:srgbClr val="A4A3A4"/>
          </p15:clr>
        </p15:guide>
        <p15:guide id="3" pos="129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9D9D9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>
        <p:scale>
          <a:sx n="80" d="100"/>
          <a:sy n="80" d="100"/>
        </p:scale>
        <p:origin x="1524" y="-680"/>
      </p:cViewPr>
      <p:guideLst>
        <p:guide orient="horz" pos="5157"/>
        <p:guide pos="2082"/>
        <p:guide pos="129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0" cy="72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直方图!$C$141</c:f>
              <c:strCache>
                <c:ptCount val="1"/>
                <c:pt idx="0">
                  <c:v>Frequenc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直方图!$B$142:$B$149</c:f>
              <c:numCache>
                <c:formatCode>0.00</c:formatCode>
                <c:ptCount val="8"/>
                <c:pt idx="0">
                  <c:v>18</c:v>
                </c:pt>
                <c:pt idx="1">
                  <c:v>19.319128571428571</c:v>
                </c:pt>
                <c:pt idx="2">
                  <c:v>20.638257142857142</c:v>
                </c:pt>
                <c:pt idx="3">
                  <c:v>21.957385714285714</c:v>
                </c:pt>
                <c:pt idx="4">
                  <c:v>23.276514285714285</c:v>
                </c:pt>
                <c:pt idx="5">
                  <c:v>24.595642857142856</c:v>
                </c:pt>
                <c:pt idx="6">
                  <c:v>25.914771428571427</c:v>
                </c:pt>
                <c:pt idx="7">
                  <c:v>27.233899999999998</c:v>
                </c:pt>
              </c:numCache>
            </c:numRef>
          </c:cat>
          <c:val>
            <c:numRef>
              <c:f>直方图!$C$142:$C$149</c:f>
              <c:numCache>
                <c:formatCode>General</c:formatCode>
                <c:ptCount val="8"/>
                <c:pt idx="0">
                  <c:v>1</c:v>
                </c:pt>
                <c:pt idx="1">
                  <c:v>5</c:v>
                </c:pt>
                <c:pt idx="2">
                  <c:v>16</c:v>
                </c:pt>
                <c:pt idx="3">
                  <c:v>21</c:v>
                </c:pt>
                <c:pt idx="4">
                  <c:v>27</c:v>
                </c:pt>
                <c:pt idx="5">
                  <c:v>17</c:v>
                </c:pt>
                <c:pt idx="6">
                  <c:v>8</c:v>
                </c:pt>
                <c:pt idx="7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6BE-427A-8F5B-47B990C4D2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773760"/>
        <c:axId val="22775296"/>
      </c:barChart>
      <c:catAx>
        <c:axId val="22773760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2775296"/>
        <c:crosses val="autoZero"/>
        <c:auto val="1"/>
        <c:lblAlgn val="ctr"/>
        <c:lblOffset val="100"/>
        <c:noMultiLvlLbl val="0"/>
      </c:catAx>
      <c:valAx>
        <c:axId val="2277529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2773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0">
          <a:solidFill>
            <a:schemeClr val="tx1"/>
          </a:solidFill>
          <a:effectLst/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直方图!$F$141</c:f>
              <c:strCache>
                <c:ptCount val="1"/>
                <c:pt idx="0">
                  <c:v>Frequenc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直方图!$E$142:$E$149</c:f>
              <c:numCache>
                <c:formatCode>0.00</c:formatCode>
                <c:ptCount val="8"/>
                <c:pt idx="0">
                  <c:v>7</c:v>
                </c:pt>
                <c:pt idx="1">
                  <c:v>7.2558571428571428</c:v>
                </c:pt>
                <c:pt idx="2">
                  <c:v>7.5117142857142856</c:v>
                </c:pt>
                <c:pt idx="3">
                  <c:v>7.7675714285714283</c:v>
                </c:pt>
                <c:pt idx="4">
                  <c:v>8.0234285714285711</c:v>
                </c:pt>
                <c:pt idx="5">
                  <c:v>8.279285714285713</c:v>
                </c:pt>
                <c:pt idx="6">
                  <c:v>8.5351428571428549</c:v>
                </c:pt>
                <c:pt idx="7">
                  <c:v>8.7909999999999968</c:v>
                </c:pt>
              </c:numCache>
            </c:numRef>
          </c:cat>
          <c:val>
            <c:numRef>
              <c:f>直方图!$F$142:$F$149</c:f>
              <c:numCache>
                <c:formatCode>General</c:formatCode>
                <c:ptCount val="8"/>
                <c:pt idx="0">
                  <c:v>1</c:v>
                </c:pt>
                <c:pt idx="1">
                  <c:v>5</c:v>
                </c:pt>
                <c:pt idx="2">
                  <c:v>32</c:v>
                </c:pt>
                <c:pt idx="3">
                  <c:v>22</c:v>
                </c:pt>
                <c:pt idx="4">
                  <c:v>17</c:v>
                </c:pt>
                <c:pt idx="5">
                  <c:v>16</c:v>
                </c:pt>
                <c:pt idx="6">
                  <c:v>3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18-4449-88C9-AC379CFAE3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0641280"/>
        <c:axId val="151207936"/>
      </c:barChart>
      <c:catAx>
        <c:axId val="150641280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1207936"/>
        <c:crosses val="autoZero"/>
        <c:auto val="1"/>
        <c:lblAlgn val="ctr"/>
        <c:lblOffset val="100"/>
        <c:noMultiLvlLbl val="0"/>
      </c:catAx>
      <c:valAx>
        <c:axId val="151207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/>
                  <a:t>No. of plants</a:t>
                </a:r>
                <a:endParaRPr lang="zh-CN" sz="10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0641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直方图!$I$141</c:f>
              <c:strCache>
                <c:ptCount val="1"/>
                <c:pt idx="0">
                  <c:v>Frequenc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直方图!$H$142:$H$149</c:f>
              <c:numCache>
                <c:formatCode>0.00</c:formatCode>
                <c:ptCount val="8"/>
                <c:pt idx="0">
                  <c:v>2.85</c:v>
                </c:pt>
                <c:pt idx="1">
                  <c:v>2.9244285714285714</c:v>
                </c:pt>
                <c:pt idx="2">
                  <c:v>2.9988571428571427</c:v>
                </c:pt>
                <c:pt idx="3">
                  <c:v>3.073285714285714</c:v>
                </c:pt>
                <c:pt idx="4">
                  <c:v>3.1477142857142852</c:v>
                </c:pt>
                <c:pt idx="5">
                  <c:v>3.2221428571428565</c:v>
                </c:pt>
                <c:pt idx="6">
                  <c:v>3.2965714285714278</c:v>
                </c:pt>
                <c:pt idx="7">
                  <c:v>3.3709999999999991</c:v>
                </c:pt>
              </c:numCache>
            </c:numRef>
          </c:cat>
          <c:val>
            <c:numRef>
              <c:f>直方图!$I$142:$I$149</c:f>
              <c:numCache>
                <c:formatCode>General</c:formatCode>
                <c:ptCount val="8"/>
                <c:pt idx="0">
                  <c:v>1</c:v>
                </c:pt>
                <c:pt idx="1">
                  <c:v>1</c:v>
                </c:pt>
                <c:pt idx="2">
                  <c:v>8</c:v>
                </c:pt>
                <c:pt idx="3">
                  <c:v>15</c:v>
                </c:pt>
                <c:pt idx="4">
                  <c:v>25</c:v>
                </c:pt>
                <c:pt idx="5">
                  <c:v>24</c:v>
                </c:pt>
                <c:pt idx="6">
                  <c:v>16</c:v>
                </c:pt>
                <c:pt idx="7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EB-46E1-940C-F57F563628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1400832"/>
        <c:axId val="151402368"/>
      </c:barChart>
      <c:catAx>
        <c:axId val="151400832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1402368"/>
        <c:crosses val="autoZero"/>
        <c:auto val="1"/>
        <c:lblAlgn val="ctr"/>
        <c:lblOffset val="100"/>
        <c:noMultiLvlLbl val="0"/>
      </c:catAx>
      <c:valAx>
        <c:axId val="15140236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1400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130</c:f>
              <c:strCache>
                <c:ptCount val="1"/>
                <c:pt idx="0">
                  <c:v>Frequenc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A$131:$A$138</c:f>
              <c:numCache>
                <c:formatCode>0.00</c:formatCode>
                <c:ptCount val="8"/>
                <c:pt idx="0">
                  <c:v>18.7</c:v>
                </c:pt>
                <c:pt idx="1">
                  <c:v>19.474128571428569</c:v>
                </c:pt>
                <c:pt idx="2">
                  <c:v>20.248257142857138</c:v>
                </c:pt>
                <c:pt idx="3">
                  <c:v>21.022385714285708</c:v>
                </c:pt>
                <c:pt idx="4">
                  <c:v>21.796514285714277</c:v>
                </c:pt>
                <c:pt idx="5">
                  <c:v>22.570642857142847</c:v>
                </c:pt>
                <c:pt idx="6">
                  <c:v>23.344771428571416</c:v>
                </c:pt>
                <c:pt idx="7">
                  <c:v>24.118899999999986</c:v>
                </c:pt>
              </c:numCache>
            </c:numRef>
          </c:cat>
          <c:val>
            <c:numRef>
              <c:f>Sheet2!$B$131:$B$138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2</c:v>
                </c:pt>
                <c:pt idx="3">
                  <c:v>6</c:v>
                </c:pt>
                <c:pt idx="4">
                  <c:v>15</c:v>
                </c:pt>
                <c:pt idx="5">
                  <c:v>25</c:v>
                </c:pt>
                <c:pt idx="6">
                  <c:v>38</c:v>
                </c:pt>
                <c:pt idx="7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0F-40BC-884F-74C8E5A687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1581824"/>
        <c:axId val="153776896"/>
      </c:barChart>
      <c:catAx>
        <c:axId val="151581824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3776896"/>
        <c:crosses val="autoZero"/>
        <c:auto val="1"/>
        <c:lblAlgn val="ctr"/>
        <c:lblOffset val="100"/>
        <c:noMultiLvlLbl val="0"/>
      </c:catAx>
      <c:valAx>
        <c:axId val="15377689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>
                <a:alpha val="99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15818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E$130</c:f>
              <c:strCache>
                <c:ptCount val="1"/>
                <c:pt idx="0">
                  <c:v>Frequenc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D$131:$D$138</c:f>
              <c:numCache>
                <c:formatCode>0.00</c:formatCode>
                <c:ptCount val="8"/>
                <c:pt idx="0">
                  <c:v>6.5</c:v>
                </c:pt>
                <c:pt idx="1">
                  <c:v>6.5708571428571432</c:v>
                </c:pt>
                <c:pt idx="2">
                  <c:v>6.6417142857142863</c:v>
                </c:pt>
                <c:pt idx="3">
                  <c:v>6.7125714285714295</c:v>
                </c:pt>
                <c:pt idx="4">
                  <c:v>6.7834285714285727</c:v>
                </c:pt>
                <c:pt idx="5">
                  <c:v>6.8542857142857159</c:v>
                </c:pt>
                <c:pt idx="6">
                  <c:v>6.925142857142859</c:v>
                </c:pt>
                <c:pt idx="7">
                  <c:v>6.9960000000000022</c:v>
                </c:pt>
              </c:numCache>
            </c:numRef>
          </c:cat>
          <c:val>
            <c:numRef>
              <c:f>Sheet2!$E$131:$E$138</c:f>
              <c:numCache>
                <c:formatCode>General</c:formatCode>
                <c:ptCount val="8"/>
                <c:pt idx="0">
                  <c:v>1</c:v>
                </c:pt>
                <c:pt idx="1">
                  <c:v>1</c:v>
                </c:pt>
                <c:pt idx="2">
                  <c:v>9</c:v>
                </c:pt>
                <c:pt idx="3">
                  <c:v>22</c:v>
                </c:pt>
                <c:pt idx="4">
                  <c:v>26</c:v>
                </c:pt>
                <c:pt idx="5">
                  <c:v>20</c:v>
                </c:pt>
                <c:pt idx="6">
                  <c:v>17</c:v>
                </c:pt>
                <c:pt idx="7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88D-4DC7-91DD-8AE4017384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8665344"/>
        <c:axId val="158685440"/>
      </c:barChart>
      <c:catAx>
        <c:axId val="158665344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8685440"/>
        <c:crosses val="autoZero"/>
        <c:auto val="1"/>
        <c:lblAlgn val="ctr"/>
        <c:lblOffset val="100"/>
        <c:noMultiLvlLbl val="0"/>
      </c:catAx>
      <c:valAx>
        <c:axId val="1586854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000" dirty="0">
                    <a:solidFill>
                      <a:schemeClr val="tx1"/>
                    </a:solidFill>
                  </a:rPr>
                  <a:t>No. of plants</a:t>
                </a:r>
                <a:endParaRPr lang="zh-CN" altLang="en-US" sz="10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8665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H$130</c:f>
              <c:strCache>
                <c:ptCount val="1"/>
                <c:pt idx="0">
                  <c:v>Frequenc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G$131:$G$138</c:f>
              <c:numCache>
                <c:formatCode>0.00</c:formatCode>
                <c:ptCount val="8"/>
                <c:pt idx="0">
                  <c:v>3.07</c:v>
                </c:pt>
                <c:pt idx="1">
                  <c:v>3.1037142857142856</c:v>
                </c:pt>
                <c:pt idx="2">
                  <c:v>3.1374285714285715</c:v>
                </c:pt>
                <c:pt idx="3">
                  <c:v>3.1711428571428573</c:v>
                </c:pt>
                <c:pt idx="4">
                  <c:v>3.2048571428571431</c:v>
                </c:pt>
                <c:pt idx="5">
                  <c:v>3.2385714285714289</c:v>
                </c:pt>
                <c:pt idx="6">
                  <c:v>3.2722857142857147</c:v>
                </c:pt>
                <c:pt idx="7">
                  <c:v>3.3060000000000005</c:v>
                </c:pt>
              </c:numCache>
            </c:numRef>
          </c:cat>
          <c:val>
            <c:numRef>
              <c:f>Sheet2!$H$131:$H$138</c:f>
              <c:numCache>
                <c:formatCode>General</c:formatCode>
                <c:ptCount val="8"/>
                <c:pt idx="0">
                  <c:v>2</c:v>
                </c:pt>
                <c:pt idx="1">
                  <c:v>2</c:v>
                </c:pt>
                <c:pt idx="2">
                  <c:v>12</c:v>
                </c:pt>
                <c:pt idx="3">
                  <c:v>28</c:v>
                </c:pt>
                <c:pt idx="4">
                  <c:v>20</c:v>
                </c:pt>
                <c:pt idx="5">
                  <c:v>23</c:v>
                </c:pt>
                <c:pt idx="6">
                  <c:v>12</c:v>
                </c:pt>
                <c:pt idx="7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A6-4502-83E7-F489FF2DDE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510720"/>
        <c:axId val="160512256"/>
      </c:barChart>
      <c:catAx>
        <c:axId val="160510720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60512256"/>
        <c:crosses val="autoZero"/>
        <c:auto val="1"/>
        <c:lblAlgn val="ctr"/>
        <c:lblOffset val="100"/>
        <c:noMultiLvlLbl val="0"/>
      </c:catAx>
      <c:valAx>
        <c:axId val="16051225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6051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直方图!$B$172</c:f>
              <c:strCache>
                <c:ptCount val="1"/>
                <c:pt idx="0">
                  <c:v>Frequenc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直方图!$A$173:$A$180</c:f>
              <c:numCache>
                <c:formatCode>0.00</c:formatCode>
                <c:ptCount val="8"/>
                <c:pt idx="0">
                  <c:v>19.32</c:v>
                </c:pt>
                <c:pt idx="1">
                  <c:v>20.177742857142857</c:v>
                </c:pt>
                <c:pt idx="2">
                  <c:v>21.035485714285713</c:v>
                </c:pt>
                <c:pt idx="3">
                  <c:v>21.893228571428569</c:v>
                </c:pt>
                <c:pt idx="4">
                  <c:v>22.750971428571425</c:v>
                </c:pt>
                <c:pt idx="5">
                  <c:v>23.608714285714282</c:v>
                </c:pt>
                <c:pt idx="6">
                  <c:v>24.466457142857138</c:v>
                </c:pt>
                <c:pt idx="7">
                  <c:v>25.324199999999994</c:v>
                </c:pt>
              </c:numCache>
            </c:numRef>
          </c:cat>
          <c:val>
            <c:numRef>
              <c:f>直方图!$B$173:$B$180</c:f>
              <c:numCache>
                <c:formatCode>General</c:formatCode>
                <c:ptCount val="8"/>
                <c:pt idx="0">
                  <c:v>1</c:v>
                </c:pt>
                <c:pt idx="1">
                  <c:v>9</c:v>
                </c:pt>
                <c:pt idx="2">
                  <c:v>35</c:v>
                </c:pt>
                <c:pt idx="3">
                  <c:v>20</c:v>
                </c:pt>
                <c:pt idx="4">
                  <c:v>19</c:v>
                </c:pt>
                <c:pt idx="5">
                  <c:v>8</c:v>
                </c:pt>
                <c:pt idx="6">
                  <c:v>3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C4-459B-B1CF-BD63BC0800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337920"/>
        <c:axId val="160339456"/>
      </c:barChart>
      <c:catAx>
        <c:axId val="160337920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60339456"/>
        <c:crosses val="autoZero"/>
        <c:auto val="1"/>
        <c:lblAlgn val="ctr"/>
        <c:lblOffset val="100"/>
        <c:noMultiLvlLbl val="0"/>
      </c:catAx>
      <c:valAx>
        <c:axId val="16033945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60337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直方图!$F$172</c:f>
              <c:strCache>
                <c:ptCount val="1"/>
                <c:pt idx="0">
                  <c:v>Frequenc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直方图!$E$173:$E$180</c:f>
              <c:numCache>
                <c:formatCode>0.00</c:formatCode>
                <c:ptCount val="8"/>
                <c:pt idx="0">
                  <c:v>7.05</c:v>
                </c:pt>
                <c:pt idx="1">
                  <c:v>7.149571428571428</c:v>
                </c:pt>
                <c:pt idx="2">
                  <c:v>7.2491428571428562</c:v>
                </c:pt>
                <c:pt idx="3">
                  <c:v>7.3487142857142844</c:v>
                </c:pt>
                <c:pt idx="4">
                  <c:v>7.4482857142857126</c:v>
                </c:pt>
                <c:pt idx="5">
                  <c:v>7.5478571428571408</c:v>
                </c:pt>
                <c:pt idx="6">
                  <c:v>7.647428571428569</c:v>
                </c:pt>
                <c:pt idx="7">
                  <c:v>7.7469999999999972</c:v>
                </c:pt>
              </c:numCache>
            </c:numRef>
          </c:cat>
          <c:val>
            <c:numRef>
              <c:f>直方图!$F$173:$F$180</c:f>
              <c:numCache>
                <c:formatCode>General</c:formatCode>
                <c:ptCount val="8"/>
                <c:pt idx="0">
                  <c:v>3</c:v>
                </c:pt>
                <c:pt idx="1">
                  <c:v>12</c:v>
                </c:pt>
                <c:pt idx="2">
                  <c:v>17</c:v>
                </c:pt>
                <c:pt idx="3">
                  <c:v>26</c:v>
                </c:pt>
                <c:pt idx="4">
                  <c:v>20</c:v>
                </c:pt>
                <c:pt idx="5">
                  <c:v>12</c:v>
                </c:pt>
                <c:pt idx="6">
                  <c:v>4</c:v>
                </c:pt>
                <c:pt idx="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51-4CA7-A33A-0BEBC1CDB8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971584"/>
        <c:axId val="51973120"/>
      </c:barChart>
      <c:catAx>
        <c:axId val="51971584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1973120"/>
        <c:crosses val="autoZero"/>
        <c:auto val="1"/>
        <c:lblAlgn val="ctr"/>
        <c:lblOffset val="100"/>
        <c:noMultiLvlLbl val="0"/>
      </c:catAx>
      <c:valAx>
        <c:axId val="519731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/>
                  <a:t>No. of plants</a:t>
                </a:r>
                <a:endParaRPr lang="zh-CN" sz="10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1971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858215130023638"/>
          <c:y val="5.0925925925925923E-2"/>
          <c:w val="0.82011465721040189"/>
          <c:h val="0.768618865691012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直方图!$I$172</c:f>
              <c:strCache>
                <c:ptCount val="1"/>
                <c:pt idx="0">
                  <c:v>Frequency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直方图!$H$173:$H$180</c:f>
              <c:numCache>
                <c:formatCode>0.00</c:formatCode>
                <c:ptCount val="8"/>
                <c:pt idx="0">
                  <c:v>2.9</c:v>
                </c:pt>
                <c:pt idx="1">
                  <c:v>2.952</c:v>
                </c:pt>
                <c:pt idx="2">
                  <c:v>3.004</c:v>
                </c:pt>
                <c:pt idx="3">
                  <c:v>3.056</c:v>
                </c:pt>
                <c:pt idx="4">
                  <c:v>3.1080000000000001</c:v>
                </c:pt>
                <c:pt idx="5">
                  <c:v>3.16</c:v>
                </c:pt>
                <c:pt idx="6">
                  <c:v>3.2120000000000002</c:v>
                </c:pt>
                <c:pt idx="7">
                  <c:v>3.2640000000000002</c:v>
                </c:pt>
              </c:numCache>
            </c:numRef>
          </c:cat>
          <c:val>
            <c:numRef>
              <c:f>直方图!$I$173:$I$180</c:f>
              <c:numCache>
                <c:formatCode>General</c:formatCode>
                <c:ptCount val="8"/>
                <c:pt idx="0">
                  <c:v>4</c:v>
                </c:pt>
                <c:pt idx="1">
                  <c:v>15</c:v>
                </c:pt>
                <c:pt idx="2">
                  <c:v>27</c:v>
                </c:pt>
                <c:pt idx="3">
                  <c:v>24</c:v>
                </c:pt>
                <c:pt idx="4">
                  <c:v>18</c:v>
                </c:pt>
                <c:pt idx="5">
                  <c:v>6</c:v>
                </c:pt>
                <c:pt idx="6">
                  <c:v>1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FE-4894-ACF6-DDEDADFE6B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759360"/>
        <c:axId val="53765248"/>
      </c:barChart>
      <c:catAx>
        <c:axId val="53759360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3765248"/>
        <c:crosses val="autoZero"/>
        <c:auto val="1"/>
        <c:lblAlgn val="ctr"/>
        <c:lblOffset val="100"/>
        <c:noMultiLvlLbl val="0"/>
      </c:catAx>
      <c:valAx>
        <c:axId val="5376524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3759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9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11300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674325" y="1219200"/>
            <a:ext cx="5512050" cy="34272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 b="1" i="0" spc="30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674325" y="4747200"/>
            <a:ext cx="5512050" cy="1963200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18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 dirty="0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1643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25" y="1032000"/>
            <a:ext cx="6172200" cy="7310400"/>
          </a:xfrm>
        </p:spPr>
        <p:txBody>
          <a:bodyPr/>
          <a:lstStyle>
            <a:lvl1pPr marL="171450" indent="-171450" eaLnBrk="1" fontAlgn="auto" latinLnBrk="0" hangingPunct="1">
              <a:lnSpc>
                <a:spcPct val="13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514350" indent="-17145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857250" indent="-17145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200150" indent="-17145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1543050" indent="-17145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  <p:extLst>
      <p:ext uri="{BB962C8B-B14F-4D97-AF65-F5344CB8AC3E}">
        <p14:creationId xmlns:p14="http://schemas.microsoft.com/office/powerpoint/2010/main" val="428039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25" y="3312000"/>
            <a:ext cx="5512050" cy="13584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45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25" y="4747200"/>
            <a:ext cx="5512050" cy="6288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  <p:extLst>
      <p:ext uri="{BB962C8B-B14F-4D97-AF65-F5344CB8AC3E}">
        <p14:creationId xmlns:p14="http://schemas.microsoft.com/office/powerpoint/2010/main" val="972257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11200"/>
            <a:ext cx="6170175" cy="9408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42225" y="1987200"/>
            <a:ext cx="6170175" cy="6345600"/>
          </a:xfrm>
        </p:spPr>
        <p:txBody>
          <a:bodyPr vert="horz" lIns="90000" tIns="46800" rIns="90000" bIns="4680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●"/>
              <a:defRPr kumimoji="0" lang="zh-CN" altLang="en-US" sz="13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8699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119825" y="5131200"/>
            <a:ext cx="4369950" cy="10224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 b="1" i="0" u="none" strike="noStrike" kern="1200" cap="none" spc="300" normalizeH="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119825" y="6153600"/>
            <a:ext cx="4369950" cy="1156800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350" b="0" i="0" u="none" strike="noStrike" kern="1200" cap="none" spc="150" normalizeH="0" baseline="0" noProof="1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3963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11200"/>
            <a:ext cx="6170175" cy="9408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42225" y="2001600"/>
            <a:ext cx="2911950" cy="6331200"/>
          </a:xfrm>
        </p:spPr>
        <p:txBody>
          <a:bodyPr vert="horz" lIns="90000" tIns="46800" rIns="90000" bIns="4680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606525" y="2001600"/>
            <a:ext cx="2911950" cy="6331200"/>
          </a:xfrm>
        </p:spPr>
        <p:txBody>
          <a:bodyPr lIns="90000" tIns="46800" rIns="90000" bIns="46800">
            <a:normAutofit/>
          </a:bodyPr>
          <a:lstStyle>
            <a:lvl1pPr marL="171450" indent="-171450" eaLnBrk="1" fontAlgn="auto" latinLnBrk="0" hangingPunct="1">
              <a:lnSpc>
                <a:spcPct val="13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sz="12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514350" indent="-17145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sz="12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857250" indent="-17145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sz="12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200150" indent="-17145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sz="105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050"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87769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11200"/>
            <a:ext cx="6170175" cy="9408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42225" y="1905600"/>
            <a:ext cx="3005100" cy="508800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1500" b="1" u="none" strike="noStrike" kern="1200" cap="none" spc="200" normalizeH="0" baseline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42225" y="2472000"/>
            <a:ext cx="3005100" cy="5860800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10" y="1895639"/>
            <a:ext cx="3005100" cy="5088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1500" b="1" i="0" u="none" strike="noStrike" kern="1200" cap="none" spc="20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10" y="2472000"/>
            <a:ext cx="3005100" cy="5860800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05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2053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25" y="811200"/>
            <a:ext cx="6170175" cy="9408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7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7583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8036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186" y="2073487"/>
            <a:ext cx="2943582" cy="614426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100" y="2073600"/>
            <a:ext cx="2940300" cy="6144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342900" indent="0" defTabSz="914400" eaLnBrk="1" fontAlgn="auto" latinLnBrk="0" hangingPunct="1">
              <a:buNone/>
              <a:tabLst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 dirty="0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</a:p>
        </p:txBody>
      </p:sp>
    </p:spTree>
    <p:extLst>
      <p:ext uri="{BB962C8B-B14F-4D97-AF65-F5344CB8AC3E}">
        <p14:creationId xmlns:p14="http://schemas.microsoft.com/office/powerpoint/2010/main" val="2183453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5757075" y="1219200"/>
            <a:ext cx="587250" cy="67056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1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514350" y="1219200"/>
            <a:ext cx="5157675" cy="6705600"/>
          </a:xfrm>
        </p:spPr>
        <p:txBody>
          <a:bodyPr vert="eaVert" lIns="46800" tIns="46800" rIns="46800" bIns="46800"/>
          <a:lstStyle>
            <a:lvl1pPr marL="171450" indent="-171450" eaLnBrk="1" fontAlgn="auto" latinLnBrk="0" hangingPunct="1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514350" indent="-171450" defTabSz="9144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857250" indent="-17145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200150" indent="-171450" eaLnBrk="1" fontAlgn="auto" latinLnBrk="0" hangingPunct="1">
              <a:lnSpc>
                <a:spcPct val="120000"/>
              </a:lnSpc>
              <a:spcAft>
                <a:spcPts val="300"/>
              </a:spcAft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1543050" indent="-171450" eaLnBrk="1" fontAlgn="auto" latinLnBrk="0" hangingPunct="1">
              <a:lnSpc>
                <a:spcPct val="120000"/>
              </a:lnSpc>
              <a:spcAft>
                <a:spcPts val="300"/>
              </a:spcAft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83629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342225" y="811200"/>
            <a:ext cx="6170175" cy="9408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342225" y="1987200"/>
            <a:ext cx="6170175" cy="63456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344250" y="8419200"/>
            <a:ext cx="1518750" cy="422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2024/3/7</a:t>
            </a:fld>
            <a:endParaRPr lang="zh-CN" altLang="en-US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2315250" y="8419200"/>
            <a:ext cx="2227500" cy="422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>
              <a:solidFill>
                <a:srgbClr val="000000">
                  <a:tint val="75000"/>
                </a:srgb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4993650" y="8419200"/>
            <a:ext cx="1518750" cy="422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>
                <a:solidFill>
                  <a:srgbClr val="000000">
                    <a:tint val="75000"/>
                  </a:srgbClr>
                </a:solidFill>
              </a:rPr>
              <a:pPr/>
              <a:t>‹#›</a:t>
            </a:fld>
            <a:endParaRPr lang="zh-CN" altLang="en-US" dirty="0">
              <a:solidFill>
                <a:srgbClr val="000000">
                  <a:tint val="75000"/>
                </a:srgbClr>
              </a:solidFill>
            </a:endParaRPr>
          </a:p>
        </p:txBody>
      </p:sp>
    </p:spTree>
    <p:custDataLst>
      <p:tags r:id="rId13"/>
    </p:custDataLst>
    <p:extLst>
      <p:ext uri="{BB962C8B-B14F-4D97-AF65-F5344CB8AC3E}">
        <p14:creationId xmlns:p14="http://schemas.microsoft.com/office/powerpoint/2010/main" val="2431718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86">
            <a:extLst>
              <a:ext uri="{FF2B5EF4-FFF2-40B4-BE49-F238E27FC236}">
                <a16:creationId xmlns:a16="http://schemas.microsoft.com/office/drawing/2014/main" id="{5663E269-FA0B-4559-9197-C21A26394DBB}"/>
              </a:ext>
            </a:extLst>
          </p:cNvPr>
          <p:cNvSpPr txBox="1"/>
          <p:nvPr/>
        </p:nvSpPr>
        <p:spPr>
          <a:xfrm>
            <a:off x="691662" y="6156542"/>
            <a:ext cx="52988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Frequency distribution </a:t>
            </a:r>
            <a:r>
              <a:rPr lang="en-US" altLang="zh-CN" sz="1000">
                <a:latin typeface="Times New Roman" pitchFamily="18" charset="0"/>
                <a:cs typeface="Times New Roman" pitchFamily="18" charset="0"/>
              </a:rPr>
              <a:t>of  GL , GW 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and TGW in the three F</a:t>
            </a:r>
            <a:r>
              <a:rPr lang="en-US" altLang="zh-CN" sz="1000" baseline="-25000" dirty="0">
                <a:latin typeface="Times New Roman" pitchFamily="18" charset="0"/>
                <a:cs typeface="Times New Roman" pitchFamily="18" charset="0"/>
              </a:rPr>
              <a:t>7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populations. a: YM1. b : YM2. c: YM3, GL: grain length, GW: grain width; TGW: 1000-grain weight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556804" y="831356"/>
            <a:ext cx="5280600" cy="5169334"/>
            <a:chOff x="556804" y="1450481"/>
            <a:chExt cx="5280600" cy="5169334"/>
          </a:xfrm>
        </p:grpSpPr>
        <p:graphicFrame>
          <p:nvGraphicFramePr>
            <p:cNvPr id="2" name="图表 1">
              <a:extLst>
                <a:ext uri="{FF2B5EF4-FFF2-40B4-BE49-F238E27FC236}">
                  <a16:creationId xmlns:a16="http://schemas.microsoft.com/office/drawing/2014/main" id="{4AACAEE5-2992-4B3F-AD13-7F3FE2D5D9E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96984730"/>
                </p:ext>
              </p:extLst>
            </p:nvPr>
          </p:nvGraphicFramePr>
          <p:xfrm>
            <a:off x="4228204" y="1452050"/>
            <a:ext cx="1609200" cy="1681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图表 2">
              <a:extLst>
                <a:ext uri="{FF2B5EF4-FFF2-40B4-BE49-F238E27FC236}">
                  <a16:creationId xmlns:a16="http://schemas.microsoft.com/office/drawing/2014/main" id="{3C9810FF-9028-41CD-968B-3FD0627887B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12202177"/>
                </p:ext>
              </p:extLst>
            </p:nvPr>
          </p:nvGraphicFramePr>
          <p:xfrm>
            <a:off x="560246" y="1450481"/>
            <a:ext cx="1735200" cy="16827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图表 3">
              <a:extLst>
                <a:ext uri="{FF2B5EF4-FFF2-40B4-BE49-F238E27FC236}">
                  <a16:creationId xmlns:a16="http://schemas.microsoft.com/office/drawing/2014/main" id="{197B3F7C-5C74-488E-9593-30A4A1CD24A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92851478"/>
                </p:ext>
              </p:extLst>
            </p:nvPr>
          </p:nvGraphicFramePr>
          <p:xfrm>
            <a:off x="2440490" y="1450481"/>
            <a:ext cx="1610010" cy="16827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图表 4">
              <a:extLst>
                <a:ext uri="{FF2B5EF4-FFF2-40B4-BE49-F238E27FC236}">
                  <a16:creationId xmlns:a16="http://schemas.microsoft.com/office/drawing/2014/main" id="{01BF3F28-194E-4811-B809-D4D873A2135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94715886"/>
                </p:ext>
              </p:extLst>
            </p:nvPr>
          </p:nvGraphicFramePr>
          <p:xfrm>
            <a:off x="4228204" y="3096361"/>
            <a:ext cx="1609200" cy="1681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图表 5">
              <a:extLst>
                <a:ext uri="{FF2B5EF4-FFF2-40B4-BE49-F238E27FC236}">
                  <a16:creationId xmlns:a16="http://schemas.microsoft.com/office/drawing/2014/main" id="{808D4B6E-0152-474C-A30D-FBB629E11D9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2641117"/>
                </p:ext>
              </p:extLst>
            </p:nvPr>
          </p:nvGraphicFramePr>
          <p:xfrm>
            <a:off x="560246" y="3094792"/>
            <a:ext cx="1735200" cy="16827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图表 6">
              <a:extLst>
                <a:ext uri="{FF2B5EF4-FFF2-40B4-BE49-F238E27FC236}">
                  <a16:creationId xmlns:a16="http://schemas.microsoft.com/office/drawing/2014/main" id="{56447153-82DE-4755-80BC-9E983E0942B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88507953"/>
                </p:ext>
              </p:extLst>
            </p:nvPr>
          </p:nvGraphicFramePr>
          <p:xfrm>
            <a:off x="2440490" y="3094792"/>
            <a:ext cx="1610010" cy="16827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8" name="图表 7">
              <a:extLst>
                <a:ext uri="{FF2B5EF4-FFF2-40B4-BE49-F238E27FC236}">
                  <a16:creationId xmlns:a16="http://schemas.microsoft.com/office/drawing/2014/main" id="{8084A951-EB1C-4CE4-A1AF-3EA35DE6572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87979235"/>
                </p:ext>
              </p:extLst>
            </p:nvPr>
          </p:nvGraphicFramePr>
          <p:xfrm>
            <a:off x="4228204" y="4706031"/>
            <a:ext cx="1609200" cy="1681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9" name="图表 8">
              <a:extLst>
                <a:ext uri="{FF2B5EF4-FFF2-40B4-BE49-F238E27FC236}">
                  <a16:creationId xmlns:a16="http://schemas.microsoft.com/office/drawing/2014/main" id="{5FD6E1D7-B720-4544-A694-EF93E028C33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04452040"/>
                </p:ext>
              </p:extLst>
            </p:nvPr>
          </p:nvGraphicFramePr>
          <p:xfrm>
            <a:off x="560246" y="4706031"/>
            <a:ext cx="1735200" cy="1681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0" name="图表 9">
              <a:extLst>
                <a:ext uri="{FF2B5EF4-FFF2-40B4-BE49-F238E27FC236}">
                  <a16:creationId xmlns:a16="http://schemas.microsoft.com/office/drawing/2014/main" id="{5C46E5C3-DF67-4250-9565-29E1C6AA001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66516167"/>
                </p:ext>
              </p:extLst>
            </p:nvPr>
          </p:nvGraphicFramePr>
          <p:xfrm>
            <a:off x="2440490" y="4706031"/>
            <a:ext cx="1610010" cy="16827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D4DE52B6-1869-40EF-941D-F83703175AD6}"/>
                </a:ext>
              </a:extLst>
            </p:cNvPr>
            <p:cNvSpPr txBox="1"/>
            <p:nvPr/>
          </p:nvSpPr>
          <p:spPr>
            <a:xfrm>
              <a:off x="4960299" y="6373593"/>
              <a:ext cx="6876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GW(g)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D27473E3-13DB-4DD3-B877-777FC22EFE4D}"/>
                </a:ext>
              </a:extLst>
            </p:cNvPr>
            <p:cNvSpPr txBox="1"/>
            <p:nvPr/>
          </p:nvSpPr>
          <p:spPr>
            <a:xfrm>
              <a:off x="1179245" y="6373594"/>
              <a:ext cx="8534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(mm)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1D43F5B-E046-4E1F-9B3C-4FAB667E1DBC}"/>
                </a:ext>
              </a:extLst>
            </p:cNvPr>
            <p:cNvSpPr txBox="1"/>
            <p:nvPr/>
          </p:nvSpPr>
          <p:spPr>
            <a:xfrm>
              <a:off x="3030588" y="6373594"/>
              <a:ext cx="8534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W(mm)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6E9BC04C-46C0-446D-B039-93BBD316AAF8}"/>
                </a:ext>
              </a:extLst>
            </p:cNvPr>
            <p:cNvSpPr txBox="1"/>
            <p:nvPr/>
          </p:nvSpPr>
          <p:spPr>
            <a:xfrm>
              <a:off x="556804" y="1485488"/>
              <a:ext cx="4096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11259EED-CC5C-43E7-9A94-76AD036E19D5}"/>
                </a:ext>
              </a:extLst>
            </p:cNvPr>
            <p:cNvSpPr txBox="1"/>
            <p:nvPr/>
          </p:nvSpPr>
          <p:spPr>
            <a:xfrm>
              <a:off x="556804" y="3106500"/>
              <a:ext cx="4096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F00D418-77C3-4295-A36E-48D79B9D2202}"/>
                </a:ext>
              </a:extLst>
            </p:cNvPr>
            <p:cNvSpPr txBox="1"/>
            <p:nvPr/>
          </p:nvSpPr>
          <p:spPr>
            <a:xfrm>
              <a:off x="556804" y="4722491"/>
              <a:ext cx="4096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1069693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1_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99</TotalTime>
  <Words>70</Words>
  <Application>Microsoft Office PowerPoint</Application>
  <PresentationFormat>全屏显示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Wingdings</vt:lpstr>
      <vt:lpstr>1_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曼 殷</cp:lastModifiedBy>
  <cp:revision>406</cp:revision>
  <dcterms:created xsi:type="dcterms:W3CDTF">2019-06-19T02:08:00Z</dcterms:created>
  <dcterms:modified xsi:type="dcterms:W3CDTF">2024-03-07T13:44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463</vt:lpwstr>
  </property>
  <property fmtid="{D5CDD505-2E9C-101B-9397-08002B2CF9AE}" pid="3" name="ICV">
    <vt:lpwstr>415AE392B45F4D3E9463EF42F8F08CF3</vt:lpwstr>
  </property>
</Properties>
</file>